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61" r:id="rId2"/>
  </p:sldIdLst>
  <p:sldSz cx="6858000" cy="9144000" type="letter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3CDEF"/>
    <a:srgbClr val="FFCCCC"/>
    <a:srgbClr val="2C11F7"/>
    <a:srgbClr val="CCFFCC"/>
    <a:srgbClr val="CCCCFF"/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4" autoAdjust="0"/>
    <p:restoredTop sz="94660"/>
  </p:normalViewPr>
  <p:slideViewPr>
    <p:cSldViewPr snapToGrid="0">
      <p:cViewPr varScale="1">
        <p:scale>
          <a:sx n="77" d="100"/>
          <a:sy n="77" d="100"/>
        </p:scale>
        <p:origin x="245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94" d="100"/>
          <a:sy n="94" d="100"/>
        </p:scale>
        <p:origin x="2862" y="8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75F1C848-E130-413A-A8DA-8172A53B0D88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4C6F3B48-2B3A-4C55-BDFB-E1E416627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33520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DCB9EB20-C2EB-4A46-8805-2479D3AB5F2C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3163" y="1200150"/>
            <a:ext cx="24288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3F07D6EC-DFDD-4EE7-ACA8-6578442E63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5759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250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3039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212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359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39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764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1230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063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009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114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002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758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2"/>
          <a:srcRect r="19805" b="2757"/>
          <a:stretch/>
        </p:blipFill>
        <p:spPr>
          <a:xfrm>
            <a:off x="367729" y="2366079"/>
            <a:ext cx="2239545" cy="2082354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1262696" y="2326562"/>
            <a:ext cx="10275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anMXpr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391613" y="2321966"/>
            <a:ext cx="8782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ET3pr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5300265" y="2319246"/>
            <a:ext cx="8782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FP ORF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181078" y="1192404"/>
            <a:ext cx="3877486" cy="791623"/>
            <a:chOff x="815306" y="1196297"/>
            <a:chExt cx="2374165" cy="568311"/>
          </a:xfrm>
        </p:grpSpPr>
        <p:cxnSp>
          <p:nvCxnSpPr>
            <p:cNvPr id="37" name="Straight Connector 36"/>
            <p:cNvCxnSpPr/>
            <p:nvPr/>
          </p:nvCxnSpPr>
          <p:spPr>
            <a:xfrm flipV="1">
              <a:off x="900033" y="1432431"/>
              <a:ext cx="2261028" cy="657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40" name="Group 39"/>
            <p:cNvGrpSpPr/>
            <p:nvPr/>
          </p:nvGrpSpPr>
          <p:grpSpPr>
            <a:xfrm>
              <a:off x="2081103" y="1256718"/>
              <a:ext cx="947493" cy="237359"/>
              <a:chOff x="2244044" y="1782649"/>
              <a:chExt cx="488096" cy="207520"/>
            </a:xfrm>
          </p:grpSpPr>
          <p:cxnSp>
            <p:nvCxnSpPr>
              <p:cNvPr id="41" name="Straight Connector 40"/>
              <p:cNvCxnSpPr/>
              <p:nvPr/>
            </p:nvCxnSpPr>
            <p:spPr>
              <a:xfrm flipH="1">
                <a:off x="2247367" y="1782649"/>
                <a:ext cx="413" cy="16651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Arrow Connector 41"/>
              <p:cNvCxnSpPr/>
              <p:nvPr/>
            </p:nvCxnSpPr>
            <p:spPr>
              <a:xfrm>
                <a:off x="2244044" y="1788943"/>
                <a:ext cx="55114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Rectangle 42"/>
              <p:cNvSpPr/>
              <p:nvPr/>
            </p:nvSpPr>
            <p:spPr>
              <a:xfrm>
                <a:off x="2249286" y="1886173"/>
                <a:ext cx="482854" cy="103995"/>
              </a:xfrm>
              <a:prstGeom prst="rect">
                <a:avLst/>
              </a:prstGeom>
              <a:solidFill>
                <a:srgbClr val="79BC58"/>
              </a:solidFill>
              <a:ln w="952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FP</a:t>
                </a:r>
              </a:p>
            </p:txBody>
          </p:sp>
          <p:sp>
            <p:nvSpPr>
              <p:cNvPr id="44" name="Rectangle 43"/>
              <p:cNvSpPr/>
              <p:nvPr/>
            </p:nvSpPr>
            <p:spPr>
              <a:xfrm>
                <a:off x="2247628" y="1883354"/>
                <a:ext cx="482854" cy="106815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45" name="Straight Arrow Connector 44"/>
            <p:cNvCxnSpPr/>
            <p:nvPr/>
          </p:nvCxnSpPr>
          <p:spPr>
            <a:xfrm>
              <a:off x="1813970" y="1549705"/>
              <a:ext cx="8398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Arrow Connector 45"/>
            <p:cNvCxnSpPr/>
            <p:nvPr/>
          </p:nvCxnSpPr>
          <p:spPr>
            <a:xfrm flipH="1">
              <a:off x="1913765" y="1549705"/>
              <a:ext cx="8398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Arrow Connector 46"/>
            <p:cNvCxnSpPr/>
            <p:nvPr/>
          </p:nvCxnSpPr>
          <p:spPr>
            <a:xfrm>
              <a:off x="2680226" y="1549705"/>
              <a:ext cx="8398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Arrow Connector 47"/>
            <p:cNvCxnSpPr/>
            <p:nvPr/>
          </p:nvCxnSpPr>
          <p:spPr>
            <a:xfrm flipH="1">
              <a:off x="2772654" y="1549705"/>
              <a:ext cx="8398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Isosceles Triangle 48"/>
            <p:cNvSpPr/>
            <p:nvPr/>
          </p:nvSpPr>
          <p:spPr>
            <a:xfrm rot="5400000">
              <a:off x="1849309" y="1402282"/>
              <a:ext cx="110421" cy="45719"/>
            </a:xfrm>
            <a:prstGeom prst="triangle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1723703" y="1196297"/>
              <a:ext cx="371214" cy="1878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ATA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1" name="Straight Arrow Connector 50"/>
            <p:cNvCxnSpPr/>
            <p:nvPr/>
          </p:nvCxnSpPr>
          <p:spPr>
            <a:xfrm>
              <a:off x="1450812" y="1549705"/>
              <a:ext cx="8398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Arrow Connector 51"/>
            <p:cNvCxnSpPr/>
            <p:nvPr/>
          </p:nvCxnSpPr>
          <p:spPr>
            <a:xfrm flipH="1">
              <a:off x="1554208" y="1549705"/>
              <a:ext cx="8398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/>
          </p:nvCxnSpPr>
          <p:spPr>
            <a:xfrm>
              <a:off x="1442279" y="1256634"/>
              <a:ext cx="464" cy="16802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Arrow Connector 53"/>
            <p:cNvCxnSpPr/>
            <p:nvPr/>
          </p:nvCxnSpPr>
          <p:spPr>
            <a:xfrm flipH="1">
              <a:off x="1332419" y="1259483"/>
              <a:ext cx="111977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Rectangle 54"/>
            <p:cNvSpPr/>
            <p:nvPr/>
          </p:nvSpPr>
          <p:spPr>
            <a:xfrm>
              <a:off x="816687" y="1361501"/>
              <a:ext cx="628804" cy="134257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 i="1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anMX</a:t>
              </a:r>
              <a:endParaRPr lang="en-US" sz="1100" b="1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Rectangle 55"/>
            <p:cNvSpPr/>
            <p:nvPr/>
          </p:nvSpPr>
          <p:spPr>
            <a:xfrm>
              <a:off x="815306" y="1356339"/>
              <a:ext cx="625417" cy="13129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1235755" y="1576796"/>
              <a:ext cx="681559" cy="1878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anMXpr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1726102" y="1576796"/>
              <a:ext cx="655956" cy="1878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T3pr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627682" y="1576796"/>
              <a:ext cx="561789" cy="1878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RF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5" name="Straight Connector 4"/>
          <p:cNvCxnSpPr/>
          <p:nvPr/>
        </p:nvCxnSpPr>
        <p:spPr>
          <a:xfrm flipV="1">
            <a:off x="888016" y="3113903"/>
            <a:ext cx="5735204" cy="3251"/>
          </a:xfrm>
          <a:prstGeom prst="line">
            <a:avLst/>
          </a:prstGeom>
          <a:ln w="12700">
            <a:solidFill>
              <a:schemeClr val="bg2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1367404" y="4416376"/>
            <a:ext cx="1029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Profile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 rot="16200000">
            <a:off x="-431188" y="3204265"/>
            <a:ext cx="17700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rmalized </a:t>
            </a:r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lII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hIP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90192" y="4929368"/>
            <a:ext cx="589763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ol II ChIP over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he reporter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 four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ains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rom profile 1, 2 and 3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reporter cassette in the two profile 3 strains are located in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AM2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EG2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wo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oderately expressed genes. 3(1):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AM2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; 3(2):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EG2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All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hIP signals were normalized by that in the profile 1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train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error bars represent the standard errors among three biological replicate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Different from Figure 3B, the profile 3 strains here have normal pol II density over the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KanMXp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ET3p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but lower density over the GFP ORF, indicating that they are repressed by a different mechanism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048807" y="4150311"/>
            <a:ext cx="20079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        2     3(1)   3(2)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3"/>
          <a:srcRect l="6429" t="3438" r="22068" b="11987"/>
          <a:stretch/>
        </p:blipFill>
        <p:spPr>
          <a:xfrm>
            <a:off x="2594917" y="2444534"/>
            <a:ext cx="1980435" cy="1796209"/>
          </a:xfrm>
          <a:prstGeom prst="rect">
            <a:avLst/>
          </a:prstGeom>
        </p:spPr>
      </p:pic>
      <p:sp>
        <p:nvSpPr>
          <p:cNvPr id="39" name="TextBox 38"/>
          <p:cNvSpPr txBox="1"/>
          <p:nvPr/>
        </p:nvSpPr>
        <p:spPr>
          <a:xfrm>
            <a:off x="3402246" y="4403568"/>
            <a:ext cx="1029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Profile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3083649" y="4137503"/>
            <a:ext cx="20079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        2     3(1)   3(2)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4"/>
          <a:srcRect l="7734" t="5539" r="22657" b="13574"/>
          <a:stretch/>
        </p:blipFill>
        <p:spPr>
          <a:xfrm>
            <a:off x="4590837" y="2489775"/>
            <a:ext cx="1927654" cy="1717589"/>
          </a:xfrm>
          <a:prstGeom prst="rect">
            <a:avLst/>
          </a:prstGeom>
        </p:spPr>
      </p:pic>
      <p:sp>
        <p:nvSpPr>
          <p:cNvPr id="63" name="TextBox 62"/>
          <p:cNvSpPr txBox="1"/>
          <p:nvPr/>
        </p:nvSpPr>
        <p:spPr>
          <a:xfrm>
            <a:off x="5385490" y="4416376"/>
            <a:ext cx="1029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Profile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5066893" y="4150311"/>
            <a:ext cx="20079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        2     3(1)   3(2)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5440496" y="297899"/>
            <a:ext cx="11107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u_Fig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4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7017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43</TotalTime>
  <Words>154</Words>
  <Application>Microsoft Office PowerPoint</Application>
  <PresentationFormat>Letter Paper (8.5x11 in)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yu Du</dc:creator>
  <cp:lastModifiedBy>lucybai</cp:lastModifiedBy>
  <cp:revision>281</cp:revision>
  <cp:lastPrinted>2016-12-22T22:05:19Z</cp:lastPrinted>
  <dcterms:created xsi:type="dcterms:W3CDTF">2016-06-14T18:48:14Z</dcterms:created>
  <dcterms:modified xsi:type="dcterms:W3CDTF">2017-03-30T15:22:14Z</dcterms:modified>
</cp:coreProperties>
</file>